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920" r:id="rId2"/>
    <p:sldId id="921" r:id="rId3"/>
  </p:sldIdLst>
  <p:sldSz cx="7559675" cy="5400675"/>
  <p:notesSz cx="6858000" cy="9144000"/>
  <p:defaultTextStyle>
    <a:defPPr>
      <a:defRPr lang="en-US"/>
    </a:defPPr>
    <a:lvl1pPr marL="0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1pPr>
    <a:lvl2pPr marL="370151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2pPr>
    <a:lvl3pPr marL="740304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3pPr>
    <a:lvl4pPr marL="1110458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4pPr>
    <a:lvl5pPr marL="1480611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5pPr>
    <a:lvl6pPr marL="1850762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6pPr>
    <a:lvl7pPr marL="2220916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7pPr>
    <a:lvl8pPr marL="2591069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8pPr>
    <a:lvl9pPr marL="2961220" algn="l" defTabSz="370151" rtl="0" eaLnBrk="1" latinLnBrk="0" hangingPunct="1">
      <a:defRPr sz="145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DB87B99-87B8-4508-9627-8659BCCC623A}" v="14" dt="2026-03-08T20:27:32.3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37" autoAdjust="0"/>
    <p:restoredTop sz="88584" autoAdjust="0"/>
  </p:normalViewPr>
  <p:slideViewPr>
    <p:cSldViewPr snapToGrid="0">
      <p:cViewPr varScale="1">
        <p:scale>
          <a:sx n="170" d="100"/>
          <a:sy n="170" d="100"/>
        </p:scale>
        <p:origin x="2776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duardo Diez" userId="8bdd45de991b27a5" providerId="LiveId" clId="{863A7054-EAA4-4688-A9B8-58AB503A3D36}"/>
    <pc:docChg chg="custSel addSld delSld modSld sldOrd modMainMaster modNotesMaster">
      <pc:chgData name="Eduardo Diez" userId="8bdd45de991b27a5" providerId="LiveId" clId="{863A7054-EAA4-4688-A9B8-58AB503A3D36}" dt="2026-03-08T21:00:43.836" v="82" actId="20577"/>
      <pc:docMkLst>
        <pc:docMk/>
      </pc:docMkLst>
      <pc:sldChg chg="del">
        <pc:chgData name="Eduardo Diez" userId="8bdd45de991b27a5" providerId="LiveId" clId="{863A7054-EAA4-4688-A9B8-58AB503A3D36}" dt="2026-03-08T20:14:22.020" v="4" actId="47"/>
        <pc:sldMkLst>
          <pc:docMk/>
          <pc:sldMk cId="1244659500" sldId="919"/>
        </pc:sldMkLst>
      </pc:sldChg>
      <pc:sldChg chg="addSp delSp modSp mod modNotes modNotesTx">
        <pc:chgData name="Eduardo Diez" userId="8bdd45de991b27a5" providerId="LiveId" clId="{863A7054-EAA4-4688-A9B8-58AB503A3D36}" dt="2026-03-08T21:00:21.090" v="54" actId="6549"/>
        <pc:sldMkLst>
          <pc:docMk/>
          <pc:sldMk cId="1940099112" sldId="920"/>
        </pc:sldMkLst>
        <pc:spChg chg="add del">
          <ac:chgData name="Eduardo Diez" userId="8bdd45de991b27a5" providerId="LiveId" clId="{863A7054-EAA4-4688-A9B8-58AB503A3D36}" dt="2026-03-08T20:25:12.577" v="20" actId="478"/>
          <ac:spMkLst>
            <pc:docMk/>
            <pc:sldMk cId="1940099112" sldId="920"/>
            <ac:spMk id="2" creationId="{DAC0839C-22DD-490A-3CD4-04EF7AC3DBC0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4" creationId="{3C418F52-F12E-42E6-5EC5-2A6A5A4E0F2F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5" creationId="{7BBCFADE-829E-C698-8BE1-0876F25C4648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10" creationId="{895D099F-C24F-DD08-0B06-24CD8D46E850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11" creationId="{9CB3A875-FEBE-5750-7664-B3BEB2500589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12" creationId="{0B06C484-BAC8-054B-69D5-45EE4C538F6A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13" creationId="{6437686F-D784-77C0-37BE-EF9870C3269F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19" creationId="{F410FCD4-DA63-5B71-0987-293C9FF2659C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20" creationId="{E2465DB6-81C3-0A73-41E2-7DF3FB43C037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21" creationId="{01FA1C04-DDCC-7FDD-339D-83D31DE6EBE5}"/>
          </ac:spMkLst>
        </pc:spChg>
        <pc:spChg chg="mod">
          <ac:chgData name="Eduardo Diez" userId="8bdd45de991b27a5" providerId="LiveId" clId="{863A7054-EAA4-4688-A9B8-58AB503A3D36}" dt="2026-03-08T20:51:59.978" v="53" actId="1036"/>
          <ac:spMkLst>
            <pc:docMk/>
            <pc:sldMk cId="1940099112" sldId="920"/>
            <ac:spMk id="22" creationId="{EB95C75C-7974-7217-D0F3-93BE7D178666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24" creationId="{9558D0C9-BA7B-0CCF-E302-A15D3F7435C1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53" creationId="{40DA9201-8072-5EE6-AF37-94D86B257E48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61" creationId="{EEFFF23D-EEC8-8B36-27F8-6E39FB75BD03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66" creationId="{743C587F-C402-1726-3048-448B3D89D181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67" creationId="{78950CDC-0EA3-227D-6036-81634CC36150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k cId="1940099112" sldId="920"/>
            <ac:spMk id="69" creationId="{AAEACE8A-7223-BFD5-A541-66928AA40B40}"/>
          </ac:spMkLst>
        </pc:spChg>
      </pc:sldChg>
      <pc:sldChg chg="addSp modSp new mod ord">
        <pc:chgData name="Eduardo Diez" userId="8bdd45de991b27a5" providerId="LiveId" clId="{863A7054-EAA4-4688-A9B8-58AB503A3D36}" dt="2026-03-08T21:00:43.836" v="82" actId="20577"/>
        <pc:sldMkLst>
          <pc:docMk/>
          <pc:sldMk cId="2105577298" sldId="921"/>
        </pc:sldMkLst>
        <pc:spChg chg="add mod">
          <ac:chgData name="Eduardo Diez" userId="8bdd45de991b27a5" providerId="LiveId" clId="{863A7054-EAA4-4688-A9B8-58AB503A3D36}" dt="2026-03-08T21:00:43.836" v="82" actId="20577"/>
          <ac:spMkLst>
            <pc:docMk/>
            <pc:sldMk cId="2105577298" sldId="921"/>
            <ac:spMk id="3" creationId="{88B3D3AA-F8EB-9A04-1E5B-4521E8ADE1CB}"/>
          </ac:spMkLst>
        </pc:spChg>
      </pc:sldChg>
      <pc:sldMasterChg chg="modSp modSldLayout">
        <pc:chgData name="Eduardo Diez" userId="8bdd45de991b27a5" providerId="LiveId" clId="{863A7054-EAA4-4688-A9B8-58AB503A3D36}" dt="2026-03-08T20:25:48.040" v="21"/>
        <pc:sldMasterMkLst>
          <pc:docMk/>
          <pc:sldMasterMk cId="4224357655" sldId="2147483660"/>
        </pc:sldMasterMkLst>
        <pc:spChg chg="mod">
          <ac:chgData name="Eduardo Diez" userId="8bdd45de991b27a5" providerId="LiveId" clId="{863A7054-EAA4-4688-A9B8-58AB503A3D36}" dt="2026-03-08T20:25:48.040" v="21"/>
          <ac:spMkLst>
            <pc:docMk/>
            <pc:sldMasterMk cId="4224357655" sldId="2147483660"/>
            <ac:spMk id="2" creationId="{00000000-0000-0000-0000-000000000000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asterMk cId="4224357655" sldId="2147483660"/>
            <ac:spMk id="3" creationId="{00000000-0000-0000-0000-000000000000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asterMk cId="4224357655" sldId="2147483660"/>
            <ac:spMk id="4" creationId="{00000000-0000-0000-0000-000000000000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asterMk cId="4224357655" sldId="2147483660"/>
            <ac:spMk id="5" creationId="{00000000-0000-0000-0000-000000000000}"/>
          </ac:spMkLst>
        </pc:spChg>
        <pc:spChg chg="mod">
          <ac:chgData name="Eduardo Diez" userId="8bdd45de991b27a5" providerId="LiveId" clId="{863A7054-EAA4-4688-A9B8-58AB503A3D36}" dt="2026-03-08T20:25:48.040" v="21"/>
          <ac:spMkLst>
            <pc:docMk/>
            <pc:sldMasterMk cId="4224357655" sldId="2147483660"/>
            <ac:spMk id="6" creationId="{00000000-0000-0000-0000-000000000000}"/>
          </ac:spMkLst>
        </pc:sp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4030405846" sldId="2147483661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4030405846" sldId="2147483661"/>
              <ac:spMk id="2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4030405846" sldId="2147483661"/>
              <ac:spMk id="3" creationId="{00000000-0000-0000-0000-000000000000}"/>
            </ac:spMkLst>
          </pc:spChg>
        </pc:sldLayout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3050153815" sldId="2147483663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3050153815" sldId="2147483663"/>
              <ac:spMk id="2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3050153815" sldId="2147483663"/>
              <ac:spMk id="3" creationId="{00000000-0000-0000-0000-000000000000}"/>
            </ac:spMkLst>
          </pc:spChg>
        </pc:sldLayout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1206929427" sldId="2147483664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1206929427" sldId="2147483664"/>
              <ac:spMk id="3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1206929427" sldId="2147483664"/>
              <ac:spMk id="4" creationId="{00000000-0000-0000-0000-000000000000}"/>
            </ac:spMkLst>
          </pc:spChg>
        </pc:sldLayout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2289458223" sldId="2147483665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2289458223" sldId="2147483665"/>
              <ac:spMk id="2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2289458223" sldId="2147483665"/>
              <ac:spMk id="3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2289458223" sldId="2147483665"/>
              <ac:spMk id="4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2289458223" sldId="2147483665"/>
              <ac:spMk id="5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2289458223" sldId="2147483665"/>
              <ac:spMk id="6" creationId="{00000000-0000-0000-0000-000000000000}"/>
            </ac:spMkLst>
          </pc:spChg>
        </pc:sldLayout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765184623" sldId="2147483668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765184623" sldId="2147483668"/>
              <ac:spMk id="2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765184623" sldId="2147483668"/>
              <ac:spMk id="3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765184623" sldId="2147483668"/>
              <ac:spMk id="4" creationId="{00000000-0000-0000-0000-000000000000}"/>
            </ac:spMkLst>
          </pc:spChg>
        </pc:sldLayout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1909599356" sldId="2147483669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1909599356" sldId="2147483669"/>
              <ac:spMk id="2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1909599356" sldId="2147483669"/>
              <ac:spMk id="3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1909599356" sldId="2147483669"/>
              <ac:spMk id="4" creationId="{00000000-0000-0000-0000-000000000000}"/>
            </ac:spMkLst>
          </pc:spChg>
        </pc:sldLayoutChg>
        <pc:sldLayoutChg chg="modSp">
          <pc:chgData name="Eduardo Diez" userId="8bdd45de991b27a5" providerId="LiveId" clId="{863A7054-EAA4-4688-A9B8-58AB503A3D36}" dt="2026-03-08T20:25:48.040" v="21"/>
          <pc:sldLayoutMkLst>
            <pc:docMk/>
            <pc:sldMasterMk cId="4224357655" sldId="2147483660"/>
            <pc:sldLayoutMk cId="3658323754" sldId="2147483671"/>
          </pc:sldLayoutMkLst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3658323754" sldId="2147483671"/>
              <ac:spMk id="2" creationId="{00000000-0000-0000-0000-000000000000}"/>
            </ac:spMkLst>
          </pc:spChg>
          <pc:spChg chg="mod">
            <ac:chgData name="Eduardo Diez" userId="8bdd45de991b27a5" providerId="LiveId" clId="{863A7054-EAA4-4688-A9B8-58AB503A3D36}" dt="2026-03-08T20:25:48.040" v="21"/>
            <ac:spMkLst>
              <pc:docMk/>
              <pc:sldMasterMk cId="4224357655" sldId="2147483660"/>
              <pc:sldLayoutMk cId="3658323754" sldId="2147483671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472E85-C47E-4D5C-BBBB-5DC58F34C867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70000" y="1143000"/>
            <a:ext cx="4318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F6820A-C4CF-4A2E-A1A9-3F97D046A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658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1pPr>
    <a:lvl2pPr marL="370151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2pPr>
    <a:lvl3pPr marL="740304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3pPr>
    <a:lvl4pPr marL="1110458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4pPr>
    <a:lvl5pPr marL="1480611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5pPr>
    <a:lvl6pPr marL="1850762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6pPr>
    <a:lvl7pPr marL="2220916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7pPr>
    <a:lvl8pPr marL="2591069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8pPr>
    <a:lvl9pPr marL="2961220" algn="l" defTabSz="740304" rtl="0" eaLnBrk="1" latinLnBrk="0" hangingPunct="1">
      <a:defRPr sz="97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3C4C48-F9B6-F08B-0B65-97F1EEE10DF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C00CA2D-5102-9A82-E4D7-459FFD24003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270000" y="1143000"/>
            <a:ext cx="4318000" cy="3086100"/>
          </a:xfrm>
        </p:spPr>
        <p:txBody>
          <a:bodyPr/>
          <a:lstStyle/>
          <a:p>
            <a:endParaRPr lang="en-CA"/>
          </a:p>
        </p:txBody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05B5514-9DDD-70D3-471B-85FEB29B47B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1F92EB-1091-E5D5-8F84-14017E517EE1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9B6A0F-6326-4D4E-BC6E-234F32617D9B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88027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883862"/>
            <a:ext cx="6425724" cy="1880235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2836612"/>
            <a:ext cx="5669756" cy="1303913"/>
          </a:xfrm>
        </p:spPr>
        <p:txBody>
          <a:bodyPr/>
          <a:lstStyle>
            <a:lvl1pPr marL="0" indent="0" algn="ctr">
              <a:buNone/>
              <a:defRPr sz="2399"/>
            </a:lvl1pPr>
            <a:lvl2pPr marL="457146" indent="0" algn="ctr">
              <a:buNone/>
              <a:defRPr sz="2000"/>
            </a:lvl2pPr>
            <a:lvl3pPr marL="914295" indent="0" algn="ctr">
              <a:buNone/>
              <a:defRPr sz="1801"/>
            </a:lvl3pPr>
            <a:lvl4pPr marL="1371441" indent="0" algn="ctr">
              <a:buNone/>
              <a:defRPr sz="1600"/>
            </a:lvl4pPr>
            <a:lvl5pPr marL="1828589" indent="0" algn="ctr">
              <a:buNone/>
              <a:defRPr sz="1600"/>
            </a:lvl5pPr>
            <a:lvl6pPr marL="2285737" indent="0" algn="ctr">
              <a:buNone/>
              <a:defRPr sz="1600"/>
            </a:lvl6pPr>
            <a:lvl7pPr marL="2742884" indent="0" algn="ctr">
              <a:buNone/>
              <a:defRPr sz="1600"/>
            </a:lvl7pPr>
            <a:lvl8pPr marL="3200031" indent="0" algn="ctr">
              <a:buNone/>
              <a:defRPr sz="1600"/>
            </a:lvl8pPr>
            <a:lvl9pPr marL="365717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405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232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6" y="287536"/>
            <a:ext cx="1630056" cy="45768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35" y="287536"/>
            <a:ext cx="4795669" cy="457682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323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06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2" y="1346420"/>
            <a:ext cx="6520220" cy="224653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2" y="3614204"/>
            <a:ext cx="6520220" cy="1181397"/>
          </a:xfrm>
        </p:spPr>
        <p:txBody>
          <a:bodyPr/>
          <a:lstStyle>
            <a:lvl1pPr marL="0" indent="0">
              <a:buNone/>
              <a:defRPr sz="2399">
                <a:solidFill>
                  <a:schemeClr val="tx1"/>
                </a:solidFill>
              </a:defRPr>
            </a:lvl1pPr>
            <a:lvl2pPr marL="45714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295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44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58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7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88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0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17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153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9" y="1437680"/>
            <a:ext cx="3212862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6" y="1437680"/>
            <a:ext cx="3212862" cy="34266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92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4" y="287537"/>
            <a:ext cx="6520220" cy="104388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6" y="1323920"/>
            <a:ext cx="3198096" cy="648831"/>
          </a:xfrm>
        </p:spPr>
        <p:txBody>
          <a:bodyPr anchor="b"/>
          <a:lstStyle>
            <a:lvl1pPr marL="0" indent="0">
              <a:buNone/>
              <a:defRPr sz="2399" b="1"/>
            </a:lvl1pPr>
            <a:lvl2pPr marL="457146" indent="0">
              <a:buNone/>
              <a:defRPr sz="2000" b="1"/>
            </a:lvl2pPr>
            <a:lvl3pPr marL="914295" indent="0">
              <a:buNone/>
              <a:defRPr sz="1801" b="1"/>
            </a:lvl3pPr>
            <a:lvl4pPr marL="1371441" indent="0">
              <a:buNone/>
              <a:defRPr sz="1600" b="1"/>
            </a:lvl4pPr>
            <a:lvl5pPr marL="1828589" indent="0">
              <a:buNone/>
              <a:defRPr sz="1600" b="1"/>
            </a:lvl5pPr>
            <a:lvl6pPr marL="2285737" indent="0">
              <a:buNone/>
              <a:defRPr sz="1600" b="1"/>
            </a:lvl6pPr>
            <a:lvl7pPr marL="2742884" indent="0">
              <a:buNone/>
              <a:defRPr sz="1600" b="1"/>
            </a:lvl7pPr>
            <a:lvl8pPr marL="3200031" indent="0">
              <a:buNone/>
              <a:defRPr sz="1600" b="1"/>
            </a:lvl8pPr>
            <a:lvl9pPr marL="365717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6" y="1972747"/>
            <a:ext cx="3198096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1323920"/>
            <a:ext cx="3213846" cy="648831"/>
          </a:xfrm>
        </p:spPr>
        <p:txBody>
          <a:bodyPr anchor="b"/>
          <a:lstStyle>
            <a:lvl1pPr marL="0" indent="0">
              <a:buNone/>
              <a:defRPr sz="2399" b="1"/>
            </a:lvl1pPr>
            <a:lvl2pPr marL="457146" indent="0">
              <a:buNone/>
              <a:defRPr sz="2000" b="1"/>
            </a:lvl2pPr>
            <a:lvl3pPr marL="914295" indent="0">
              <a:buNone/>
              <a:defRPr sz="1801" b="1"/>
            </a:lvl3pPr>
            <a:lvl4pPr marL="1371441" indent="0">
              <a:buNone/>
              <a:defRPr sz="1600" b="1"/>
            </a:lvl4pPr>
            <a:lvl5pPr marL="1828589" indent="0">
              <a:buNone/>
              <a:defRPr sz="1600" b="1"/>
            </a:lvl5pPr>
            <a:lvl6pPr marL="2285737" indent="0">
              <a:buNone/>
              <a:defRPr sz="1600" b="1"/>
            </a:lvl6pPr>
            <a:lvl7pPr marL="2742884" indent="0">
              <a:buNone/>
              <a:defRPr sz="1600" b="1"/>
            </a:lvl7pPr>
            <a:lvl8pPr marL="3200031" indent="0">
              <a:buNone/>
              <a:defRPr sz="1600" b="1"/>
            </a:lvl8pPr>
            <a:lvl9pPr marL="365717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1972747"/>
            <a:ext cx="3213846" cy="290161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458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801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3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4" y="360051"/>
            <a:ext cx="2438192" cy="1260158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9" y="777605"/>
            <a:ext cx="3827085" cy="3837980"/>
          </a:xfrm>
        </p:spPr>
        <p:txBody>
          <a:bodyPr/>
          <a:lstStyle>
            <a:lvl1pPr>
              <a:defRPr sz="3200"/>
            </a:lvl1pPr>
            <a:lvl2pPr>
              <a:defRPr sz="2799"/>
            </a:lvl2pPr>
            <a:lvl3pPr>
              <a:defRPr sz="2399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4" y="1620209"/>
            <a:ext cx="2438192" cy="3001626"/>
          </a:xfrm>
        </p:spPr>
        <p:txBody>
          <a:bodyPr/>
          <a:lstStyle>
            <a:lvl1pPr marL="0" indent="0">
              <a:buNone/>
              <a:defRPr sz="1600"/>
            </a:lvl1pPr>
            <a:lvl2pPr marL="457146" indent="0">
              <a:buNone/>
              <a:defRPr sz="1401"/>
            </a:lvl2pPr>
            <a:lvl3pPr marL="914295" indent="0">
              <a:buNone/>
              <a:defRPr sz="1200"/>
            </a:lvl3pPr>
            <a:lvl4pPr marL="1371441" indent="0">
              <a:buNone/>
              <a:defRPr sz="1001"/>
            </a:lvl4pPr>
            <a:lvl5pPr marL="1828589" indent="0">
              <a:buNone/>
              <a:defRPr sz="1001"/>
            </a:lvl5pPr>
            <a:lvl6pPr marL="2285737" indent="0">
              <a:buNone/>
              <a:defRPr sz="1001"/>
            </a:lvl6pPr>
            <a:lvl7pPr marL="2742884" indent="0">
              <a:buNone/>
              <a:defRPr sz="1001"/>
            </a:lvl7pPr>
            <a:lvl8pPr marL="3200031" indent="0">
              <a:buNone/>
              <a:defRPr sz="1001"/>
            </a:lvl8pPr>
            <a:lvl9pPr marL="3657179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184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4" y="360051"/>
            <a:ext cx="2438192" cy="1260158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9" y="777605"/>
            <a:ext cx="3827085" cy="3837980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46" indent="0">
              <a:buNone/>
              <a:defRPr sz="2799"/>
            </a:lvl2pPr>
            <a:lvl3pPr marL="914295" indent="0">
              <a:buNone/>
              <a:defRPr sz="2399"/>
            </a:lvl3pPr>
            <a:lvl4pPr marL="1371441" indent="0">
              <a:buNone/>
              <a:defRPr sz="2000"/>
            </a:lvl4pPr>
            <a:lvl5pPr marL="1828589" indent="0">
              <a:buNone/>
              <a:defRPr sz="2000"/>
            </a:lvl5pPr>
            <a:lvl6pPr marL="2285737" indent="0">
              <a:buNone/>
              <a:defRPr sz="2000"/>
            </a:lvl6pPr>
            <a:lvl7pPr marL="2742884" indent="0">
              <a:buNone/>
              <a:defRPr sz="2000"/>
            </a:lvl7pPr>
            <a:lvl8pPr marL="3200031" indent="0">
              <a:buNone/>
              <a:defRPr sz="2000"/>
            </a:lvl8pPr>
            <a:lvl9pPr marL="365717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4" y="1620209"/>
            <a:ext cx="2438192" cy="3001626"/>
          </a:xfrm>
        </p:spPr>
        <p:txBody>
          <a:bodyPr/>
          <a:lstStyle>
            <a:lvl1pPr marL="0" indent="0">
              <a:buNone/>
              <a:defRPr sz="1600"/>
            </a:lvl1pPr>
            <a:lvl2pPr marL="457146" indent="0">
              <a:buNone/>
              <a:defRPr sz="1401"/>
            </a:lvl2pPr>
            <a:lvl3pPr marL="914295" indent="0">
              <a:buNone/>
              <a:defRPr sz="1200"/>
            </a:lvl3pPr>
            <a:lvl4pPr marL="1371441" indent="0">
              <a:buNone/>
              <a:defRPr sz="1001"/>
            </a:lvl4pPr>
            <a:lvl5pPr marL="1828589" indent="0">
              <a:buNone/>
              <a:defRPr sz="1001"/>
            </a:lvl5pPr>
            <a:lvl6pPr marL="2285737" indent="0">
              <a:buNone/>
              <a:defRPr sz="1001"/>
            </a:lvl6pPr>
            <a:lvl7pPr marL="2742884" indent="0">
              <a:buNone/>
              <a:defRPr sz="1001"/>
            </a:lvl7pPr>
            <a:lvl8pPr marL="3200031" indent="0">
              <a:buNone/>
              <a:defRPr sz="1001"/>
            </a:lvl8pPr>
            <a:lvl9pPr marL="3657179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59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30" y="287537"/>
            <a:ext cx="6520220" cy="10438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30" y="1437680"/>
            <a:ext cx="6520220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5005628"/>
            <a:ext cx="170092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B5AF7-146B-433E-ABFB-BC2A49FA19CD}" type="datetimeFigureOut">
              <a:rPr lang="en-US" smtClean="0"/>
              <a:t>3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5005628"/>
            <a:ext cx="2551390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1" y="5005628"/>
            <a:ext cx="1700927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BF523B-BFAF-48B2-B631-9AF89F33C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357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295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74" indent="-228574" algn="l" defTabSz="914295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19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2pPr>
      <a:lvl3pPr marL="1142868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7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2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311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458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8605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5752" indent="-228574" algn="l" defTabSz="914295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146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295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1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589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7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4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031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179" algn="l" defTabSz="91429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85D190-A491-9E4E-7EC8-3CD4081DA31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 72">
            <a:extLst>
              <a:ext uri="{FF2B5EF4-FFF2-40B4-BE49-F238E27FC236}">
                <a16:creationId xmlns:a16="http://schemas.microsoft.com/office/drawing/2014/main" id="{CEA9A6CB-B1FF-1539-1BD1-4A128CEAB2DF}"/>
              </a:ext>
            </a:extLst>
          </p:cNvPr>
          <p:cNvGrpSpPr/>
          <p:nvPr/>
        </p:nvGrpSpPr>
        <p:grpSpPr>
          <a:xfrm>
            <a:off x="436873" y="351916"/>
            <a:ext cx="6685928" cy="4446737"/>
            <a:chOff x="1260529" y="1080573"/>
            <a:chExt cx="6685928" cy="4446737"/>
          </a:xfrm>
        </p:grpSpPr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D6591ED9-7189-B96D-3432-B1683808C807}"/>
                </a:ext>
              </a:extLst>
            </p:cNvPr>
            <p:cNvCxnSpPr/>
            <p:nvPr/>
          </p:nvCxnSpPr>
          <p:spPr>
            <a:xfrm>
              <a:off x="7432762" y="5460723"/>
              <a:ext cx="37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D5216B9E-7CC4-8C33-31E8-879FFFB710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6221" t="28372" r="41254" b="28156"/>
            <a:stretch/>
          </p:blipFill>
          <p:spPr>
            <a:xfrm>
              <a:off x="1318195" y="1111351"/>
              <a:ext cx="1620000" cy="216000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39562E95-C3B8-2CA3-16C8-B89EB63860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6250" t="28373" r="41265" b="28155"/>
            <a:stretch/>
          </p:blipFill>
          <p:spPr>
            <a:xfrm>
              <a:off x="2972737" y="1111351"/>
              <a:ext cx="1620000" cy="2160000"/>
            </a:xfrm>
            <a:prstGeom prst="rect">
              <a:avLst/>
            </a:prstGeom>
          </p:spPr>
        </p:pic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BAA5E208-95C5-5DA9-897A-3DD096DDDD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6406" t="23341" r="27489" b="36984"/>
            <a:stretch/>
          </p:blipFill>
          <p:spPr>
            <a:xfrm>
              <a:off x="1318195" y="3367310"/>
              <a:ext cx="1620001" cy="2160000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3466B396-18C9-2041-B775-E19F7804A9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6514" t="23440" r="27577" b="37017"/>
            <a:stretch/>
          </p:blipFill>
          <p:spPr>
            <a:xfrm>
              <a:off x="2972737" y="3367310"/>
              <a:ext cx="1620000" cy="2160000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15CC0E4B-61BB-5EB0-26AD-6AE9AE8126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7447" t="35386" r="40305" b="21564"/>
            <a:stretch/>
          </p:blipFill>
          <p:spPr>
            <a:xfrm>
              <a:off x="6326455" y="3367310"/>
              <a:ext cx="1620002" cy="2160000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CFCED365-F94A-5E80-1AA3-2EDA129E17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7447" t="35386" r="40305" b="21564"/>
            <a:stretch/>
          </p:blipFill>
          <p:spPr>
            <a:xfrm>
              <a:off x="4677748" y="3367310"/>
              <a:ext cx="1620001" cy="2160000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79389232-46C6-440C-1F73-1AE6A2714F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43673" t="25964" r="27569" b="35059"/>
            <a:stretch/>
          </p:blipFill>
          <p:spPr>
            <a:xfrm>
              <a:off x="6326455" y="1111351"/>
              <a:ext cx="1620000" cy="2160000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065D4F81-4250-1217-2F2F-C809E96C10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3651" t="25960" r="27529" b="35063"/>
            <a:stretch/>
          </p:blipFill>
          <p:spPr>
            <a:xfrm>
              <a:off x="4677748" y="1111351"/>
              <a:ext cx="1620000" cy="216000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558D0C9-BA7B-0CCF-E302-A15D3F7435C1}"/>
                </a:ext>
              </a:extLst>
            </p:cNvPr>
            <p:cNvSpPr txBox="1"/>
            <p:nvPr/>
          </p:nvSpPr>
          <p:spPr>
            <a:xfrm>
              <a:off x="1261638" y="1080573"/>
              <a:ext cx="984052" cy="656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199"/>
                </a:lnSpc>
              </a:pPr>
              <a:r>
                <a:rPr lang="en-CA" sz="2000" i="1" dirty="0">
                  <a:solidFill>
                    <a:schemeClr val="bg1"/>
                  </a:solidFill>
                </a:rPr>
                <a:t>Eml3</a:t>
              </a:r>
              <a:r>
                <a:rPr lang="en-CA" sz="2399" baseline="20000" dirty="0">
                  <a:solidFill>
                    <a:schemeClr val="bg1"/>
                  </a:solidFill>
                </a:rPr>
                <a:t>+/+</a:t>
              </a:r>
            </a:p>
            <a:p>
              <a:pPr>
                <a:lnSpc>
                  <a:spcPts val="2199"/>
                </a:lnSpc>
              </a:pPr>
              <a:r>
                <a:rPr lang="en-CA" sz="2000" dirty="0">
                  <a:solidFill>
                    <a:schemeClr val="bg1"/>
                  </a:solidFill>
                </a:rPr>
                <a:t>E9.5</a:t>
              </a:r>
              <a:endParaRPr lang="en-CA" sz="1173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410FCD4-DA63-5B71-0987-293C9FF2659C}"/>
                </a:ext>
              </a:extLst>
            </p:cNvPr>
            <p:cNvSpPr txBox="1"/>
            <p:nvPr/>
          </p:nvSpPr>
          <p:spPr>
            <a:xfrm>
              <a:off x="1276217" y="2985979"/>
              <a:ext cx="667170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73" dirty="0">
                  <a:solidFill>
                    <a:srgbClr val="00FF00"/>
                  </a:solidFill>
                </a:rPr>
                <a:t>Lamini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2465DB6-81C3-0A73-41E2-7DF3FB43C037}"/>
                </a:ext>
              </a:extLst>
            </p:cNvPr>
            <p:cNvSpPr txBox="1"/>
            <p:nvPr/>
          </p:nvSpPr>
          <p:spPr>
            <a:xfrm>
              <a:off x="2929956" y="2985979"/>
              <a:ext cx="867545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73" dirty="0">
                  <a:solidFill>
                    <a:srgbClr val="FF0000"/>
                  </a:solidFill>
                </a:rPr>
                <a:t>Collagen IV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1FA1C04-DDCC-7FDD-339D-83D31DE6EBE5}"/>
                </a:ext>
              </a:extLst>
            </p:cNvPr>
            <p:cNvSpPr txBox="1"/>
            <p:nvPr/>
          </p:nvSpPr>
          <p:spPr>
            <a:xfrm>
              <a:off x="4645609" y="2985979"/>
              <a:ext cx="1104790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73" dirty="0">
                  <a:solidFill>
                    <a:srgbClr val="00FF00"/>
                  </a:solidFill>
                </a:rPr>
                <a:t>α</a:t>
              </a:r>
              <a:r>
                <a:rPr lang="en-CA" sz="1173" dirty="0">
                  <a:solidFill>
                    <a:srgbClr val="00FF00"/>
                  </a:solidFill>
                </a:rPr>
                <a:t>-Dystroglycan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B95C75C-7974-7217-D0F3-93BE7D178666}"/>
                </a:ext>
              </a:extLst>
            </p:cNvPr>
            <p:cNvSpPr txBox="1"/>
            <p:nvPr/>
          </p:nvSpPr>
          <p:spPr>
            <a:xfrm>
              <a:off x="6323249" y="2985979"/>
              <a:ext cx="859531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73" dirty="0">
                  <a:solidFill>
                    <a:srgbClr val="FF0000"/>
                  </a:solidFill>
                </a:rPr>
                <a:t>Integrin </a:t>
              </a:r>
              <a:r>
                <a:rPr lang="el-GR" sz="1173" dirty="0">
                  <a:solidFill>
                    <a:srgbClr val="FF0000"/>
                  </a:solidFill>
                </a:rPr>
                <a:t>α</a:t>
              </a:r>
              <a:r>
                <a:rPr lang="en-CA" sz="1173" dirty="0">
                  <a:solidFill>
                    <a:srgbClr val="FF0000"/>
                  </a:solidFill>
                </a:rPr>
                <a:t>6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1C6947B-7A8D-70D6-1DF5-55796779FA24}"/>
                </a:ext>
              </a:extLst>
            </p:cNvPr>
            <p:cNvSpPr txBox="1"/>
            <p:nvPr/>
          </p:nvSpPr>
          <p:spPr>
            <a:xfrm>
              <a:off x="1260529" y="3334929"/>
              <a:ext cx="926344" cy="656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199"/>
                </a:lnSpc>
              </a:pPr>
              <a:r>
                <a:rPr lang="en-CA" sz="2000" i="1" dirty="0">
                  <a:solidFill>
                    <a:schemeClr val="bg1"/>
                  </a:solidFill>
                </a:rPr>
                <a:t>Eml3</a:t>
              </a:r>
              <a:r>
                <a:rPr lang="en-CA" sz="2799" baseline="20000" dirty="0">
                  <a:solidFill>
                    <a:schemeClr val="bg1"/>
                  </a:solidFill>
                </a:rPr>
                <a:t>-</a:t>
              </a:r>
              <a:r>
                <a:rPr lang="en-CA" sz="2399" baseline="20000" dirty="0">
                  <a:solidFill>
                    <a:schemeClr val="bg1"/>
                  </a:solidFill>
                </a:rPr>
                <a:t>/</a:t>
              </a:r>
              <a:r>
                <a:rPr lang="en-CA" sz="2799" baseline="20000" dirty="0">
                  <a:solidFill>
                    <a:schemeClr val="bg1"/>
                  </a:solidFill>
                </a:rPr>
                <a:t>-</a:t>
              </a:r>
            </a:p>
            <a:p>
              <a:pPr>
                <a:lnSpc>
                  <a:spcPts val="2199"/>
                </a:lnSpc>
              </a:pPr>
              <a:r>
                <a:rPr lang="en-CA" sz="2000" dirty="0">
                  <a:solidFill>
                    <a:schemeClr val="bg1"/>
                  </a:solidFill>
                </a:rPr>
                <a:t>E9.5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C418F52-F12E-42E6-5EC5-2A6A5A4E0F2F}"/>
                </a:ext>
              </a:extLst>
            </p:cNvPr>
            <p:cNvSpPr txBox="1"/>
            <p:nvPr/>
          </p:nvSpPr>
          <p:spPr>
            <a:xfrm>
              <a:off x="2476102" y="1770903"/>
              <a:ext cx="529312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PBM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BBCFADE-829E-C698-8BE1-0876F25C4648}"/>
                </a:ext>
              </a:extLst>
            </p:cNvPr>
            <p:cNvSpPr txBox="1"/>
            <p:nvPr/>
          </p:nvSpPr>
          <p:spPr>
            <a:xfrm>
              <a:off x="2476102" y="1287238"/>
              <a:ext cx="492443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MM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8E4616F-85A0-8C9F-3B79-6AD48812D6BF}"/>
                </a:ext>
              </a:extLst>
            </p:cNvPr>
            <p:cNvSpPr txBox="1"/>
            <p:nvPr/>
          </p:nvSpPr>
          <p:spPr>
            <a:xfrm>
              <a:off x="2476102" y="2383479"/>
              <a:ext cx="388248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NE</a:t>
              </a: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6A6B4FA7-4F13-ACE8-F6DB-60F2A4433102}"/>
                </a:ext>
              </a:extLst>
            </p:cNvPr>
            <p:cNvCxnSpPr>
              <a:cxnSpLocks/>
            </p:cNvCxnSpPr>
            <p:nvPr/>
          </p:nvCxnSpPr>
          <p:spPr>
            <a:xfrm>
              <a:off x="2486351" y="5444200"/>
              <a:ext cx="37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95D099F-C24F-DD08-0B06-24CD8D46E850}"/>
                </a:ext>
              </a:extLst>
            </p:cNvPr>
            <p:cNvSpPr txBox="1"/>
            <p:nvPr/>
          </p:nvSpPr>
          <p:spPr>
            <a:xfrm>
              <a:off x="1276217" y="5241177"/>
              <a:ext cx="667170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73" dirty="0">
                  <a:solidFill>
                    <a:srgbClr val="00FF00"/>
                  </a:solidFill>
                </a:rPr>
                <a:t>Lamini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CB3A875-FEBE-5750-7664-B3BEB2500589}"/>
                </a:ext>
              </a:extLst>
            </p:cNvPr>
            <p:cNvSpPr txBox="1"/>
            <p:nvPr/>
          </p:nvSpPr>
          <p:spPr>
            <a:xfrm>
              <a:off x="2929956" y="5241177"/>
              <a:ext cx="867545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73" dirty="0">
                  <a:solidFill>
                    <a:srgbClr val="FF0000"/>
                  </a:solidFill>
                </a:rPr>
                <a:t>Collagen IV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B06C484-BAC8-054B-69D5-45EE4C538F6A}"/>
                </a:ext>
              </a:extLst>
            </p:cNvPr>
            <p:cNvSpPr txBox="1"/>
            <p:nvPr/>
          </p:nvSpPr>
          <p:spPr>
            <a:xfrm>
              <a:off x="4645609" y="5241177"/>
              <a:ext cx="1104790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73" dirty="0">
                  <a:solidFill>
                    <a:srgbClr val="00FF00"/>
                  </a:solidFill>
                </a:rPr>
                <a:t>α</a:t>
              </a:r>
              <a:r>
                <a:rPr lang="en-CA" sz="1173" dirty="0">
                  <a:solidFill>
                    <a:srgbClr val="00FF00"/>
                  </a:solidFill>
                </a:rPr>
                <a:t>-Dystroglycan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437686F-D784-77C0-37BE-EF9870C3269F}"/>
                </a:ext>
              </a:extLst>
            </p:cNvPr>
            <p:cNvSpPr txBox="1"/>
            <p:nvPr/>
          </p:nvSpPr>
          <p:spPr>
            <a:xfrm>
              <a:off x="6323249" y="5241177"/>
              <a:ext cx="859531" cy="272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73" dirty="0">
                  <a:solidFill>
                    <a:srgbClr val="FF0000"/>
                  </a:solidFill>
                </a:rPr>
                <a:t>Integrin </a:t>
              </a:r>
              <a:r>
                <a:rPr lang="el-GR" sz="1173" dirty="0">
                  <a:solidFill>
                    <a:srgbClr val="FF0000"/>
                  </a:solidFill>
                </a:rPr>
                <a:t>α</a:t>
              </a:r>
              <a:r>
                <a:rPr lang="en-CA" sz="1173" dirty="0">
                  <a:solidFill>
                    <a:srgbClr val="FF0000"/>
                  </a:solidFill>
                </a:rPr>
                <a:t>6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752BD5B-855C-059F-8BBA-9D0E97CFC286}"/>
                </a:ext>
              </a:extLst>
            </p:cNvPr>
            <p:cNvSpPr txBox="1"/>
            <p:nvPr/>
          </p:nvSpPr>
          <p:spPr>
            <a:xfrm>
              <a:off x="2476102" y="4135579"/>
              <a:ext cx="529312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PBM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CE6B64D-7990-3EE5-EB98-76B3BABA4A44}"/>
                </a:ext>
              </a:extLst>
            </p:cNvPr>
            <p:cNvSpPr txBox="1"/>
            <p:nvPr/>
          </p:nvSpPr>
          <p:spPr>
            <a:xfrm>
              <a:off x="2476102" y="3651916"/>
              <a:ext cx="492443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MM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8F4870E-C3EE-FF31-82BE-1578942022C6}"/>
                </a:ext>
              </a:extLst>
            </p:cNvPr>
            <p:cNvSpPr txBox="1"/>
            <p:nvPr/>
          </p:nvSpPr>
          <p:spPr>
            <a:xfrm>
              <a:off x="2476102" y="4748157"/>
              <a:ext cx="388248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NE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DFE7AF17-ABDF-8A64-5714-5CB1976B338A}"/>
                </a:ext>
              </a:extLst>
            </p:cNvPr>
            <p:cNvCxnSpPr>
              <a:cxnSpLocks/>
            </p:cNvCxnSpPr>
            <p:nvPr/>
          </p:nvCxnSpPr>
          <p:spPr>
            <a:xfrm>
              <a:off x="2486351" y="3188781"/>
              <a:ext cx="37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0DA9201-8072-5EE6-AF37-94D86B257E48}"/>
                </a:ext>
              </a:extLst>
            </p:cNvPr>
            <p:cNvSpPr txBox="1"/>
            <p:nvPr/>
          </p:nvSpPr>
          <p:spPr>
            <a:xfrm>
              <a:off x="4626795" y="1080573"/>
              <a:ext cx="984052" cy="656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199"/>
                </a:lnSpc>
              </a:pPr>
              <a:r>
                <a:rPr lang="en-CA" sz="2000" i="1" dirty="0">
                  <a:solidFill>
                    <a:schemeClr val="bg1"/>
                  </a:solidFill>
                </a:rPr>
                <a:t>Eml3</a:t>
              </a:r>
              <a:r>
                <a:rPr lang="en-CA" sz="2399" baseline="20000" dirty="0">
                  <a:solidFill>
                    <a:schemeClr val="bg1"/>
                  </a:solidFill>
                </a:rPr>
                <a:t>+/+</a:t>
              </a:r>
            </a:p>
            <a:p>
              <a:pPr>
                <a:lnSpc>
                  <a:spcPts val="2199"/>
                </a:lnSpc>
              </a:pPr>
              <a:r>
                <a:rPr lang="en-CA" sz="2000" dirty="0">
                  <a:solidFill>
                    <a:schemeClr val="bg1"/>
                  </a:solidFill>
                </a:rPr>
                <a:t>E9.5</a:t>
              </a:r>
              <a:endParaRPr lang="en-CA" sz="1173" dirty="0">
                <a:solidFill>
                  <a:schemeClr val="bg1"/>
                </a:solidFill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EFFF23D-EEC8-8B36-27F8-6E39FB75BD03}"/>
                </a:ext>
              </a:extLst>
            </p:cNvPr>
            <p:cNvSpPr txBox="1"/>
            <p:nvPr/>
          </p:nvSpPr>
          <p:spPr>
            <a:xfrm>
              <a:off x="4625686" y="3334929"/>
              <a:ext cx="926344" cy="656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199"/>
                </a:lnSpc>
              </a:pPr>
              <a:r>
                <a:rPr lang="en-CA" sz="2000" i="1" dirty="0">
                  <a:solidFill>
                    <a:schemeClr val="bg1"/>
                  </a:solidFill>
                </a:rPr>
                <a:t>Eml3</a:t>
              </a:r>
              <a:r>
                <a:rPr lang="en-CA" sz="2799" baseline="20000" dirty="0">
                  <a:solidFill>
                    <a:schemeClr val="bg1"/>
                  </a:solidFill>
                </a:rPr>
                <a:t>-</a:t>
              </a:r>
              <a:r>
                <a:rPr lang="en-CA" sz="2399" baseline="20000" dirty="0">
                  <a:solidFill>
                    <a:schemeClr val="bg1"/>
                  </a:solidFill>
                </a:rPr>
                <a:t>/</a:t>
              </a:r>
              <a:r>
                <a:rPr lang="en-CA" sz="2799" baseline="20000" dirty="0">
                  <a:solidFill>
                    <a:schemeClr val="bg1"/>
                  </a:solidFill>
                </a:rPr>
                <a:t>-</a:t>
              </a:r>
            </a:p>
            <a:p>
              <a:pPr>
                <a:lnSpc>
                  <a:spcPts val="2199"/>
                </a:lnSpc>
              </a:pPr>
              <a:r>
                <a:rPr lang="en-CA" sz="2000" dirty="0">
                  <a:solidFill>
                    <a:schemeClr val="bg1"/>
                  </a:solidFill>
                </a:rPr>
                <a:t>E9.5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95460AE9-2CFD-FFBA-4EE8-D508D3DC8092}"/>
                </a:ext>
              </a:extLst>
            </p:cNvPr>
            <p:cNvSpPr txBox="1"/>
            <p:nvPr/>
          </p:nvSpPr>
          <p:spPr>
            <a:xfrm>
              <a:off x="5841262" y="1775019"/>
              <a:ext cx="529312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PBM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43C587F-C402-1726-3048-448B3D89D181}"/>
                </a:ext>
              </a:extLst>
            </p:cNvPr>
            <p:cNvSpPr txBox="1"/>
            <p:nvPr/>
          </p:nvSpPr>
          <p:spPr>
            <a:xfrm>
              <a:off x="5841262" y="1291355"/>
              <a:ext cx="492443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MM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8950CDC-0EA3-227D-6036-81634CC36150}"/>
                </a:ext>
              </a:extLst>
            </p:cNvPr>
            <p:cNvSpPr txBox="1"/>
            <p:nvPr/>
          </p:nvSpPr>
          <p:spPr>
            <a:xfrm>
              <a:off x="5841262" y="2387595"/>
              <a:ext cx="388248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NE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63183090-E6F0-54B9-8F2B-56A6E9702A2B}"/>
                </a:ext>
              </a:extLst>
            </p:cNvPr>
            <p:cNvCxnSpPr>
              <a:cxnSpLocks/>
            </p:cNvCxnSpPr>
            <p:nvPr/>
          </p:nvCxnSpPr>
          <p:spPr>
            <a:xfrm>
              <a:off x="5851509" y="5448316"/>
              <a:ext cx="37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AEACE8A-7223-BFD5-A541-66928AA40B40}"/>
                </a:ext>
              </a:extLst>
            </p:cNvPr>
            <p:cNvSpPr txBox="1"/>
            <p:nvPr/>
          </p:nvSpPr>
          <p:spPr>
            <a:xfrm>
              <a:off x="5841262" y="4139695"/>
              <a:ext cx="529312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PBM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EEADD88-BAD3-CC34-3F2C-D7EAD324257D}"/>
                </a:ext>
              </a:extLst>
            </p:cNvPr>
            <p:cNvSpPr txBox="1"/>
            <p:nvPr/>
          </p:nvSpPr>
          <p:spPr>
            <a:xfrm>
              <a:off x="5841262" y="3656031"/>
              <a:ext cx="492443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MM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37B9603-104E-270B-05E9-21785476A4F2}"/>
                </a:ext>
              </a:extLst>
            </p:cNvPr>
            <p:cNvSpPr txBox="1"/>
            <p:nvPr/>
          </p:nvSpPr>
          <p:spPr>
            <a:xfrm>
              <a:off x="5841262" y="4752272"/>
              <a:ext cx="388248" cy="3079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1" dirty="0">
                  <a:solidFill>
                    <a:schemeClr val="bg1"/>
                  </a:solidFill>
                </a:rPr>
                <a:t>NE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7893D20E-DCDC-E1CE-DD24-20B3EC74CC7D}"/>
                </a:ext>
              </a:extLst>
            </p:cNvPr>
            <p:cNvCxnSpPr>
              <a:cxnSpLocks/>
            </p:cNvCxnSpPr>
            <p:nvPr/>
          </p:nvCxnSpPr>
          <p:spPr>
            <a:xfrm>
              <a:off x="5851509" y="3192897"/>
              <a:ext cx="378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40099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8B3D3AA-F8EB-9A04-1E5B-4521E8ADE1CB}"/>
              </a:ext>
            </a:extLst>
          </p:cNvPr>
          <p:cNvSpPr txBox="1"/>
          <p:nvPr/>
        </p:nvSpPr>
        <p:spPr>
          <a:xfrm>
            <a:off x="336004" y="412151"/>
            <a:ext cx="6904246" cy="23957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Supp. Fig. 2. Components of the PBM in stage-matched E9.5 </a:t>
            </a:r>
            <a:r>
              <a:rPr lang="en-CA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ml3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+/+ and </a:t>
            </a:r>
            <a:r>
              <a:rPr lang="en-CA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ml3</a:t>
            </a:r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-/- embryos.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unolabeling of the pial basement membrane on sections of developing brains from stage-matched E9.5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ml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/+ (top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ml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/- (bottom) mouse embryos. Antibodies against the major components of the extracellular matrix of the PBM: laminin (green, left) and collagen IV (red, left), as well as for the major ECM component receptors expressed on the end-feet of neuroepithelial cells: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dystroglycan (green, right) and integrin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6 (red, right) were used. MM, meningeal mesenchyme; NE, neuroepithelium; PBM, pial basement membrane. Scale bar, 10µm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endParaRPr lang="en-CA" sz="18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5577298"/>
      </p:ext>
    </p:extLst>
  </p:cSld>
  <p:clrMapOvr>
    <a:masterClrMapping/>
  </p:clrMapOvr>
</p:sld>
</file>

<file path=ppt/theme/theme1.xml><?xml version="1.0" encoding="utf-8"?>
<a:theme xmlns:a="http://schemas.openxmlformats.org/drawingml/2006/main" name="four three ratio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our three ratio" id="{16792E23-B77A-4080-9C06-0B83B5412622}" vid="{DE91DDAD-7784-4643-A1D8-D880780A674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657</TotalTime>
  <Words>173</Words>
  <Application>Microsoft Office PowerPoint</Application>
  <PresentationFormat>Custom</PresentationFormat>
  <Paragraphs>3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four three ratio</vt:lpstr>
      <vt:lpstr>PowerPoint Presentation</vt:lpstr>
      <vt:lpstr>PowerPoint Presentation</vt:lpstr>
    </vt:vector>
  </TitlesOfParts>
  <Company>Office 365 for LD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sabelle Carrier</dc:creator>
  <cp:lastModifiedBy>Eduardo Diez</cp:lastModifiedBy>
  <cp:revision>6</cp:revision>
  <dcterms:created xsi:type="dcterms:W3CDTF">2025-12-05T17:31:32Z</dcterms:created>
  <dcterms:modified xsi:type="dcterms:W3CDTF">2026-03-08T21:22:09Z</dcterms:modified>
</cp:coreProperties>
</file>